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handoutMasterIdLst>
    <p:handoutMasterId r:id="rId36"/>
  </p:handoutMasterIdLst>
  <p:sldIdLst>
    <p:sldId id="319" r:id="rId2"/>
    <p:sldId id="285" r:id="rId3"/>
    <p:sldId id="259" r:id="rId4"/>
    <p:sldId id="286" r:id="rId5"/>
    <p:sldId id="287" r:id="rId6"/>
    <p:sldId id="313" r:id="rId7"/>
    <p:sldId id="288" r:id="rId8"/>
    <p:sldId id="289" r:id="rId9"/>
    <p:sldId id="318" r:id="rId10"/>
    <p:sldId id="290" r:id="rId11"/>
    <p:sldId id="291" r:id="rId12"/>
    <p:sldId id="292" r:id="rId13"/>
    <p:sldId id="293" r:id="rId14"/>
    <p:sldId id="294" r:id="rId15"/>
    <p:sldId id="295" r:id="rId16"/>
    <p:sldId id="296" r:id="rId17"/>
    <p:sldId id="297" r:id="rId18"/>
    <p:sldId id="298" r:id="rId19"/>
    <p:sldId id="299" r:id="rId20"/>
    <p:sldId id="300" r:id="rId21"/>
    <p:sldId id="301" r:id="rId22"/>
    <p:sldId id="302" r:id="rId23"/>
    <p:sldId id="303" r:id="rId24"/>
    <p:sldId id="304" r:id="rId25"/>
    <p:sldId id="305" r:id="rId26"/>
    <p:sldId id="306" r:id="rId27"/>
    <p:sldId id="307" r:id="rId28"/>
    <p:sldId id="308" r:id="rId29"/>
    <p:sldId id="315" r:id="rId30"/>
    <p:sldId id="316" r:id="rId31"/>
    <p:sldId id="309" r:id="rId32"/>
    <p:sldId id="310" r:id="rId33"/>
    <p:sldId id="311" r:id="rId34"/>
    <p:sldId id="314" r:id="rId35"/>
  </p:sldIdLst>
  <p:sldSz cx="13208000" cy="9906000"/>
  <p:notesSz cx="6858000" cy="9144000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  <p:ext uri="{2D200454-40CA-4A62-9FC3-DE9A4176ACB9}">
      <p15:notes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-120" y="-150"/>
      </p:cViewPr>
      <p:guideLst>
        <p:guide orient="horz" pos="3120"/>
        <p:guide pos="416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58" d="100"/>
          <a:sy n="58" d="100"/>
        </p:scale>
        <p:origin x="2808" y="7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presProps" Target="presProps.xml"/><Relationship Id="rId40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handoutMaster" Target="handoutMasters/handout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BE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9CF257-5050-431F-A1C1-2369B0456896}" type="datetimeFigureOut">
              <a:rPr lang="nl-BE" smtClean="0"/>
              <a:t>15/08/2016</a:t>
            </a:fld>
            <a:endParaRPr lang="nl-BE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BE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F48F39-E584-4943-B673-DA3A2C502F30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8078174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0600" y="1621191"/>
            <a:ext cx="112268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51000" y="5202944"/>
            <a:ext cx="99060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nl-NL" smtClean="0"/>
              <a:t>Klik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4B70-9E0C-49AD-B386-5E2A1ACBB6FC}" type="datetimeFigureOut">
              <a:rPr lang="nl-BE" smtClean="0"/>
              <a:t>15/08/2016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DE07-DB82-4437-9155-2C9886E7D2BB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358979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4B70-9E0C-49AD-B386-5E2A1ACBB6FC}" type="datetimeFigureOut">
              <a:rPr lang="nl-BE" smtClean="0"/>
              <a:t>15/08/2016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DE07-DB82-4437-9155-2C9886E7D2BB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7708287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451976" y="527403"/>
            <a:ext cx="2847975" cy="8394877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08051" y="527403"/>
            <a:ext cx="8378825" cy="8394877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4B70-9E0C-49AD-B386-5E2A1ACBB6FC}" type="datetimeFigureOut">
              <a:rPr lang="nl-BE" smtClean="0"/>
              <a:t>15/08/2016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DE07-DB82-4437-9155-2C9886E7D2BB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1180167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4B70-9E0C-49AD-B386-5E2A1ACBB6FC}" type="datetimeFigureOut">
              <a:rPr lang="nl-BE" smtClean="0"/>
              <a:t>15/08/2016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DE07-DB82-4437-9155-2C9886E7D2BB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1291670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1172" y="2469624"/>
            <a:ext cx="11391900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1172" y="6629226"/>
            <a:ext cx="11391900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/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4B70-9E0C-49AD-B386-5E2A1ACBB6FC}" type="datetimeFigureOut">
              <a:rPr lang="nl-BE" smtClean="0"/>
              <a:t>15/08/2016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DE07-DB82-4437-9155-2C9886E7D2BB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7659303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08050" y="2637014"/>
            <a:ext cx="5613400" cy="6285266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86550" y="2637014"/>
            <a:ext cx="5613400" cy="6285266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4B70-9E0C-49AD-B386-5E2A1ACBB6FC}" type="datetimeFigureOut">
              <a:rPr lang="nl-BE" smtClean="0"/>
              <a:t>15/08/2016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DE07-DB82-4437-9155-2C9886E7D2BB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3126306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527405"/>
            <a:ext cx="11391900" cy="1914702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9772" y="2428347"/>
            <a:ext cx="5587602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09772" y="3618442"/>
            <a:ext cx="5587602" cy="5322183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686551" y="2428347"/>
            <a:ext cx="5615120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686551" y="3618442"/>
            <a:ext cx="5615120" cy="5322183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4B70-9E0C-49AD-B386-5E2A1ACBB6FC}" type="datetimeFigureOut">
              <a:rPr lang="nl-BE" smtClean="0"/>
              <a:t>15/08/2016</a:t>
            </a:fld>
            <a:endParaRPr lang="nl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DE07-DB82-4437-9155-2C9886E7D2BB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99796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4B70-9E0C-49AD-B386-5E2A1ACBB6FC}" type="datetimeFigureOut">
              <a:rPr lang="nl-BE" smtClean="0"/>
              <a:t>15/08/2016</a:t>
            </a:fld>
            <a:endParaRPr lang="nl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DE07-DB82-4437-9155-2C9886E7D2BB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0943529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4B70-9E0C-49AD-B386-5E2A1ACBB6FC}" type="datetimeFigureOut">
              <a:rPr lang="nl-BE" smtClean="0"/>
              <a:t>15/08/2016</a:t>
            </a:fld>
            <a:endParaRPr lang="nl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DE07-DB82-4437-9155-2C9886E7D2BB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338216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660400"/>
            <a:ext cx="425992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15120" y="1426283"/>
            <a:ext cx="6686550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9770" y="2971800"/>
            <a:ext cx="425992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4B70-9E0C-49AD-B386-5E2A1ACBB6FC}" type="datetimeFigureOut">
              <a:rPr lang="nl-BE" smtClean="0"/>
              <a:t>15/08/2016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DE07-DB82-4437-9155-2C9886E7D2BB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1721296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660400"/>
            <a:ext cx="425992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15120" y="1426283"/>
            <a:ext cx="6686550" cy="7039681"/>
          </a:xfrm>
        </p:spPr>
        <p:txBody>
          <a:bodyPr anchor="t"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nl-NL" smtClean="0"/>
              <a:t>Klik op het pictogram als u een afbeelding wilt toevoe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9770" y="2971800"/>
            <a:ext cx="425992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4B70-9E0C-49AD-B386-5E2A1ACBB6FC}" type="datetimeFigureOut">
              <a:rPr lang="nl-BE" smtClean="0"/>
              <a:t>15/08/2016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DE07-DB82-4437-9155-2C9886E7D2BB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6216871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08050" y="527405"/>
            <a:ext cx="11391900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8050" y="2637014"/>
            <a:ext cx="11391900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08050" y="9181397"/>
            <a:ext cx="29718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234B70-9E0C-49AD-B386-5E2A1ACBB6FC}" type="datetimeFigureOut">
              <a:rPr lang="nl-BE" smtClean="0"/>
              <a:t>15/08/2016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375150" y="9181397"/>
            <a:ext cx="4457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328150" y="9181397"/>
            <a:ext cx="29718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9ADE07-DB82-4437-9155-2C9886E7D2BB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6328445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pn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kstvak 3"/>
          <p:cNvSpPr txBox="1"/>
          <p:nvPr/>
        </p:nvSpPr>
        <p:spPr>
          <a:xfrm>
            <a:off x="713232" y="4338066"/>
            <a:ext cx="1190548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</a:t>
            </a:r>
            <a:r>
              <a:rPr lang="en-US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le </a:t>
            </a:r>
            <a:r>
              <a:rPr lang="en-US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en-US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Pcal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transposable element families on the core and the supernumerary genome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 comprehensive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Pca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was performed on the core and the supernumerary genome separately. On the core genome, there are 13 families that show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Pca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tterns that are typical for RIP (dominance of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p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→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p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tions; red trace). On the supernumerary genome, there are no such instances. </a:t>
            </a:r>
            <a:endParaRPr lang="nl-B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239813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66689"/>
            <a:ext cx="14221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TF_</a:t>
            </a:r>
            <a:r>
              <a:rPr lang="nl-NL" i="1" dirty="0" smtClean="0"/>
              <a:t>ESP4-A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3039" y="375822"/>
            <a:ext cx="9523809" cy="4152381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33038" y="4712112"/>
            <a:ext cx="9523809" cy="41238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30353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66689"/>
            <a:ext cx="1414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TF_</a:t>
            </a:r>
            <a:r>
              <a:rPr lang="nl-NL" i="1" dirty="0" smtClean="0"/>
              <a:t>ESP4-B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0417" y="336208"/>
            <a:ext cx="9514286" cy="4228571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82606" y="4706589"/>
            <a:ext cx="9523809" cy="41714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177839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78074"/>
            <a:ext cx="146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TF_</a:t>
            </a:r>
            <a:r>
              <a:rPr lang="nl-NL" i="1" dirty="0" smtClean="0"/>
              <a:t>Drogon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5648" y="357534"/>
            <a:ext cx="9504762" cy="4152381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46124" y="4699528"/>
            <a:ext cx="9514286" cy="41904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89444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46678"/>
            <a:ext cx="1353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 smtClean="0"/>
              <a:t>DTF_</a:t>
            </a:r>
            <a:r>
              <a:rPr lang="nl-NL" i="1" dirty="0" err="1" smtClean="0"/>
              <a:t>Obara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sp>
        <p:nvSpPr>
          <p:cNvPr id="10" name="Tekstvak 9"/>
          <p:cNvSpPr txBox="1"/>
          <p:nvPr/>
        </p:nvSpPr>
        <p:spPr>
          <a:xfrm>
            <a:off x="4576064" y="2059362"/>
            <a:ext cx="4654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no alignment can be made on the core genome</a:t>
            </a:r>
            <a:endParaRPr lang="en-US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8249" y="4688705"/>
            <a:ext cx="9514286" cy="41904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79188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66689"/>
            <a:ext cx="15222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TF_</a:t>
            </a:r>
            <a:r>
              <a:rPr lang="nl-NL" i="1" dirty="0" smtClean="0"/>
              <a:t>Viserion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6911" y="338486"/>
            <a:ext cx="9523809" cy="4171429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17346" y="4706718"/>
            <a:ext cx="9514286" cy="41047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11068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66689"/>
            <a:ext cx="15318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 smtClean="0"/>
              <a:t>DTF_</a:t>
            </a:r>
            <a:r>
              <a:rPr lang="nl-NL" i="1" dirty="0" err="1" smtClean="0"/>
              <a:t>Rhaegal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3011" y="405913"/>
            <a:ext cx="9504762" cy="4085714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13011" y="4696372"/>
            <a:ext cx="9504762" cy="41428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6009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66689"/>
            <a:ext cx="1573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TA_</a:t>
            </a:r>
            <a:r>
              <a:rPr lang="nl-NL" i="1" dirty="0" smtClean="0"/>
              <a:t>Nymeria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sp>
        <p:nvSpPr>
          <p:cNvPr id="10" name="Tekstvak 9"/>
          <p:cNvSpPr txBox="1"/>
          <p:nvPr/>
        </p:nvSpPr>
        <p:spPr>
          <a:xfrm>
            <a:off x="4576064" y="2059362"/>
            <a:ext cx="4654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no alignment can be made on the core genome</a:t>
            </a:r>
            <a:endParaRPr lang="en-US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3011" y="4736324"/>
            <a:ext cx="9504762" cy="40952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89339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46678"/>
            <a:ext cx="1544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 smtClean="0"/>
              <a:t>DTF_</a:t>
            </a:r>
            <a:r>
              <a:rPr lang="nl-NL" i="1" dirty="0" err="1" smtClean="0"/>
              <a:t>Balerion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3" name="Rechthoek 2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4" name="Rechte verbindingslijn 3"/>
          <p:cNvCxnSpPr>
            <a:stCxn id="3" idx="1"/>
            <a:endCxn id="3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kstvak 5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7" name="Tekstvak 6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1775" y="331715"/>
            <a:ext cx="9523809" cy="4209524"/>
          </a:xfrm>
          <a:prstGeom prst="rect">
            <a:avLst/>
          </a:prstGeom>
        </p:spPr>
      </p:pic>
      <p:pic>
        <p:nvPicPr>
          <p:cNvPr id="9" name="Afbeelding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28705" y="4722038"/>
            <a:ext cx="9495238" cy="41238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32058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78074"/>
            <a:ext cx="13587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TM_</a:t>
            </a:r>
            <a:r>
              <a:rPr lang="nl-NL" i="1" dirty="0" smtClean="0"/>
              <a:t>Hop7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3487" y="366298"/>
            <a:ext cx="9523809" cy="4161905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12584" y="4702588"/>
            <a:ext cx="9523809" cy="41428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62418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66689"/>
            <a:ext cx="13587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TM_</a:t>
            </a:r>
            <a:r>
              <a:rPr lang="nl-NL" i="1" dirty="0" smtClean="0"/>
              <a:t>Hop4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7345" y="405913"/>
            <a:ext cx="9514286" cy="4085714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13011" y="4677387"/>
            <a:ext cx="9504762" cy="42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32087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66689"/>
            <a:ext cx="11837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TF_</a:t>
            </a:r>
            <a:r>
              <a:rPr lang="nl-NL" i="1" dirty="0" smtClean="0"/>
              <a:t>Fot2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4" name="Rechthoek 3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6" name="Rechte verbindingslijn 5"/>
          <p:cNvCxnSpPr>
            <a:stCxn id="4" idx="1"/>
            <a:endCxn id="4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kstvak 6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8" name="Tekstvak 7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pic>
        <p:nvPicPr>
          <p:cNvPr id="3" name="Afbeelding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7773" y="357265"/>
            <a:ext cx="9495238" cy="4142857"/>
          </a:xfrm>
          <a:prstGeom prst="rect">
            <a:avLst/>
          </a:prstGeom>
        </p:spPr>
      </p:pic>
      <p:pic>
        <p:nvPicPr>
          <p:cNvPr id="9" name="Afbeelding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8725" y="4702589"/>
            <a:ext cx="9514286" cy="41238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0128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46678"/>
            <a:ext cx="12121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TA_</a:t>
            </a:r>
            <a:r>
              <a:rPr lang="nl-NL" i="1" dirty="0" smtClean="0"/>
              <a:t>RLT1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sp>
        <p:nvSpPr>
          <p:cNvPr id="10" name="Tekstvak 9"/>
          <p:cNvSpPr txBox="1"/>
          <p:nvPr/>
        </p:nvSpPr>
        <p:spPr>
          <a:xfrm>
            <a:off x="4576064" y="2059362"/>
            <a:ext cx="4654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no alignment can be made on the core genome</a:t>
            </a:r>
            <a:endParaRPr lang="en-US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2108" y="4707350"/>
            <a:ext cx="9504762" cy="41333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433194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66689"/>
            <a:ext cx="12121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TA_</a:t>
            </a:r>
            <a:r>
              <a:rPr lang="nl-NL" i="1" dirty="0" smtClean="0"/>
              <a:t>RLT2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sp>
        <p:nvSpPr>
          <p:cNvPr id="10" name="Tekstvak 9"/>
          <p:cNvSpPr txBox="1"/>
          <p:nvPr/>
        </p:nvSpPr>
        <p:spPr>
          <a:xfrm>
            <a:off x="4576064" y="2059362"/>
            <a:ext cx="4654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no alignment can be made on the core genome</a:t>
            </a:r>
            <a:endParaRPr lang="en-US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7346" y="4734039"/>
            <a:ext cx="9514286" cy="41428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02153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66689"/>
            <a:ext cx="12121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TA_</a:t>
            </a:r>
            <a:r>
              <a:rPr lang="nl-NL" i="1" dirty="0" smtClean="0"/>
              <a:t>RLT3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sp>
        <p:nvSpPr>
          <p:cNvPr id="10" name="Tekstvak 9"/>
          <p:cNvSpPr txBox="1"/>
          <p:nvPr/>
        </p:nvSpPr>
        <p:spPr>
          <a:xfrm>
            <a:off x="4576064" y="2059362"/>
            <a:ext cx="4654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no alignment can be made on the core genome</a:t>
            </a:r>
            <a:endParaRPr lang="en-US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7346" y="4718234"/>
            <a:ext cx="9514286" cy="41238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50743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78074"/>
            <a:ext cx="1193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TA_</a:t>
            </a:r>
            <a:r>
              <a:rPr lang="nl-NL" i="1" dirty="0" smtClean="0"/>
              <a:t>Tfo1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7345" y="381762"/>
            <a:ext cx="9514286" cy="4133333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26869" y="4687616"/>
            <a:ext cx="9504762" cy="41238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06940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45825" y="8966689"/>
            <a:ext cx="1193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TA_</a:t>
            </a:r>
            <a:r>
              <a:rPr lang="nl-NL" i="1" dirty="0" smtClean="0"/>
              <a:t>Tfo2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sp>
        <p:nvSpPr>
          <p:cNvPr id="10" name="Tekstvak 9"/>
          <p:cNvSpPr txBox="1"/>
          <p:nvPr/>
        </p:nvSpPr>
        <p:spPr>
          <a:xfrm>
            <a:off x="4576064" y="2059362"/>
            <a:ext cx="4654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no alignment can be made on the core genome</a:t>
            </a:r>
            <a:endParaRPr lang="en-US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3011" y="4762616"/>
            <a:ext cx="9504762" cy="4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1932558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78074"/>
            <a:ext cx="15414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TA_</a:t>
            </a:r>
            <a:r>
              <a:rPr lang="nl-NL" i="1" dirty="0" smtClean="0"/>
              <a:t>Hornet1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2129" y="367058"/>
            <a:ext cx="9495238" cy="4142857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73081" y="4692796"/>
            <a:ext cx="9514286" cy="41428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7438749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66689"/>
            <a:ext cx="15414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TA_</a:t>
            </a:r>
            <a:r>
              <a:rPr lang="nl-NL" i="1" dirty="0" smtClean="0"/>
              <a:t>Hornet2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sp>
        <p:nvSpPr>
          <p:cNvPr id="10" name="Tekstvak 9"/>
          <p:cNvSpPr txBox="1"/>
          <p:nvPr/>
        </p:nvSpPr>
        <p:spPr>
          <a:xfrm>
            <a:off x="4576064" y="2059362"/>
            <a:ext cx="4654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no alignment can be made on the core genome</a:t>
            </a:r>
            <a:endParaRPr lang="en-US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2584" y="4693064"/>
            <a:ext cx="9523809" cy="41619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2356922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66689"/>
            <a:ext cx="15414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TA_</a:t>
            </a:r>
            <a:r>
              <a:rPr lang="nl-NL" i="1" dirty="0" smtClean="0"/>
              <a:t>Hornet3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sp>
        <p:nvSpPr>
          <p:cNvPr id="10" name="Tekstvak 9"/>
          <p:cNvSpPr txBox="1"/>
          <p:nvPr/>
        </p:nvSpPr>
        <p:spPr>
          <a:xfrm>
            <a:off x="4576064" y="2059362"/>
            <a:ext cx="4654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no alignment can be made on the core genome</a:t>
            </a:r>
            <a:endParaRPr lang="en-US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0512" y="4720876"/>
            <a:ext cx="9504762" cy="41428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6478292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78074"/>
            <a:ext cx="1386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 smtClean="0"/>
              <a:t>DTA_</a:t>
            </a:r>
            <a:r>
              <a:rPr lang="nl-NL" i="1" dirty="0" err="1" smtClean="0"/>
              <a:t>Drifter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sp>
        <p:nvSpPr>
          <p:cNvPr id="10" name="Tekstvak 9"/>
          <p:cNvSpPr txBox="1"/>
          <p:nvPr/>
        </p:nvSpPr>
        <p:spPr>
          <a:xfrm>
            <a:off x="4576064" y="2059362"/>
            <a:ext cx="4654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no alignment can be made on the core genome</a:t>
            </a:r>
            <a:endParaRPr lang="en-US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6061" y="4720876"/>
            <a:ext cx="9495238" cy="41428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6729149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66689"/>
            <a:ext cx="1382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 smtClean="0"/>
              <a:t>DTA_</a:t>
            </a:r>
            <a:r>
              <a:rPr lang="nl-NL" i="1" dirty="0" err="1" smtClean="0"/>
              <a:t>Obella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sp>
        <p:nvSpPr>
          <p:cNvPr id="10" name="Tekstvak 9"/>
          <p:cNvSpPr txBox="1"/>
          <p:nvPr/>
        </p:nvSpPr>
        <p:spPr>
          <a:xfrm>
            <a:off x="4576064" y="2059362"/>
            <a:ext cx="4654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no alignment can be made on the core genome</a:t>
            </a:r>
            <a:endParaRPr lang="en-US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3841" y="4694519"/>
            <a:ext cx="9514286" cy="42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87648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97322"/>
            <a:ext cx="13873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TF_</a:t>
            </a:r>
            <a:r>
              <a:rPr lang="nl-NL" i="1" dirty="0" smtClean="0"/>
              <a:t>Fot3-A</a:t>
            </a:r>
            <a:r>
              <a:rPr lang="nl-NL" dirty="0" smtClean="0"/>
              <a:t>. </a:t>
            </a:r>
            <a:endParaRPr lang="nl-BE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79457" y="495437"/>
            <a:ext cx="9408445" cy="4185720"/>
          </a:xfrm>
          <a:prstGeom prst="rect">
            <a:avLst/>
          </a:prstGeom>
        </p:spPr>
      </p:pic>
      <p:sp>
        <p:nvSpPr>
          <p:cNvPr id="3" name="Rechthoek 2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6" name="Rechte verbindingslijn 5"/>
          <p:cNvCxnSpPr>
            <a:stCxn id="3" idx="1"/>
            <a:endCxn id="3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kstvak 9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11" name="Tekstvak 10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pic>
        <p:nvPicPr>
          <p:cNvPr id="4" name="Afbeelding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49586" y="4756774"/>
            <a:ext cx="9504762" cy="41142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93016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45825" y="8956763"/>
            <a:ext cx="14144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 smtClean="0"/>
              <a:t>DTA_</a:t>
            </a:r>
            <a:r>
              <a:rPr lang="nl-NL" i="1" dirty="0" err="1" smtClean="0"/>
              <a:t>Sarella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sp>
        <p:nvSpPr>
          <p:cNvPr id="10" name="Tekstvak 9"/>
          <p:cNvSpPr txBox="1"/>
          <p:nvPr/>
        </p:nvSpPr>
        <p:spPr>
          <a:xfrm>
            <a:off x="4576064" y="2059362"/>
            <a:ext cx="4654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no alignment can be made on the core genome</a:t>
            </a:r>
            <a:endParaRPr lang="en-US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7346" y="4776033"/>
            <a:ext cx="9514286" cy="40285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6365611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46678"/>
            <a:ext cx="1374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RLG_</a:t>
            </a:r>
            <a:r>
              <a:rPr lang="nl-NL" i="1" dirty="0" smtClean="0"/>
              <a:t>Skippy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2584" y="348770"/>
            <a:ext cx="9523809" cy="4142857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08249" y="4781664"/>
            <a:ext cx="9514286" cy="41142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2143545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46678"/>
            <a:ext cx="46161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smtClean="0"/>
              <a:t>RLG_</a:t>
            </a:r>
            <a:r>
              <a:rPr lang="nl-NL" i="1" dirty="0" smtClean="0"/>
              <a:t>Maggy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6869" y="367818"/>
            <a:ext cx="9495238" cy="4123809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07821" y="4760759"/>
            <a:ext cx="9514286" cy="40761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4231794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46678"/>
            <a:ext cx="13017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RLC_</a:t>
            </a:r>
            <a:r>
              <a:rPr lang="nl-NL" i="1" dirty="0" smtClean="0"/>
              <a:t>Ghost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7345" y="380404"/>
            <a:ext cx="9514286" cy="4085714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03487" y="4678107"/>
            <a:ext cx="9523809" cy="41333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9517704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46678"/>
            <a:ext cx="13372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 smtClean="0"/>
              <a:t>Rxx_</a:t>
            </a:r>
            <a:r>
              <a:rPr lang="nl-NL" i="1" dirty="0" err="1" smtClean="0"/>
              <a:t>Marsu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sp>
        <p:nvSpPr>
          <p:cNvPr id="10" name="Tekstvak 9"/>
          <p:cNvSpPr txBox="1"/>
          <p:nvPr/>
        </p:nvSpPr>
        <p:spPr>
          <a:xfrm>
            <a:off x="4576064" y="2059362"/>
            <a:ext cx="4654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no alignment can be made on the core genome</a:t>
            </a:r>
            <a:endParaRPr lang="en-US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4274" y="4740682"/>
            <a:ext cx="9514286" cy="40666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15523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9006831"/>
            <a:ext cx="13792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TF_</a:t>
            </a:r>
            <a:r>
              <a:rPr lang="nl-NL" i="1" dirty="0" smtClean="0"/>
              <a:t>Fot3-B</a:t>
            </a:r>
            <a:r>
              <a:rPr lang="nl-NL" dirty="0" smtClean="0"/>
              <a:t>. </a:t>
            </a:r>
            <a:endParaRPr lang="nl-BE" dirty="0"/>
          </a:p>
        </p:txBody>
      </p:sp>
      <p:pic>
        <p:nvPicPr>
          <p:cNvPr id="3" name="Afbeelding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0512" y="352761"/>
            <a:ext cx="9509760" cy="4146255"/>
          </a:xfrm>
          <a:prstGeom prst="rect">
            <a:avLst/>
          </a:prstGeom>
        </p:spPr>
      </p:pic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6463" y="4762616"/>
            <a:ext cx="9523809" cy="4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20572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84977"/>
            <a:ext cx="1374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TF_</a:t>
            </a:r>
            <a:r>
              <a:rPr lang="nl-NL" i="1" dirty="0" smtClean="0"/>
              <a:t>Fot3-C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2224" y="407367"/>
            <a:ext cx="9523809" cy="4152381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2223" y="4762214"/>
            <a:ext cx="9523809" cy="41428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99067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66689"/>
            <a:ext cx="11837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TF_</a:t>
            </a:r>
            <a:r>
              <a:rPr lang="nl-NL" i="1" dirty="0" smtClean="0"/>
              <a:t>Fot4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3487" y="376313"/>
            <a:ext cx="9523809" cy="4104762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13010" y="4767378"/>
            <a:ext cx="9504762" cy="41428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97142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46678"/>
            <a:ext cx="13873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TF_</a:t>
            </a:r>
            <a:r>
              <a:rPr lang="nl-NL" i="1" dirty="0" smtClean="0"/>
              <a:t>Fot5-A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8249" y="367058"/>
            <a:ext cx="9514286" cy="4142857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8726" y="4740951"/>
            <a:ext cx="9523809" cy="41142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16037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46678"/>
            <a:ext cx="1374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TF_</a:t>
            </a:r>
            <a:r>
              <a:rPr lang="nl-NL" i="1" dirty="0" smtClean="0"/>
              <a:t>Fot5-C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7773" y="338486"/>
            <a:ext cx="9495238" cy="4171429"/>
          </a:xfrm>
          <a:prstGeom prst="rect">
            <a:avLst/>
          </a:prstGeom>
        </p:spPr>
      </p:pic>
      <p:pic>
        <p:nvPicPr>
          <p:cNvPr id="10" name="Afbeelding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17773" y="4712514"/>
            <a:ext cx="9504762" cy="41428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44697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1627632" y="8966689"/>
            <a:ext cx="11837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TF_</a:t>
            </a:r>
            <a:r>
              <a:rPr lang="nl-NL" i="1" dirty="0" smtClean="0"/>
              <a:t>Fot8</a:t>
            </a:r>
            <a:r>
              <a:rPr lang="nl-NL" dirty="0" smtClean="0"/>
              <a:t>. </a:t>
            </a:r>
            <a:endParaRPr lang="nl-BE" dirty="0"/>
          </a:p>
        </p:txBody>
      </p:sp>
      <p:sp>
        <p:nvSpPr>
          <p:cNvPr id="6" name="Rechthoek 5"/>
          <p:cNvSpPr/>
          <p:nvPr/>
        </p:nvSpPr>
        <p:spPr>
          <a:xfrm>
            <a:off x="1627632" y="256032"/>
            <a:ext cx="9875520" cy="86906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cxnSp>
        <p:nvCxnSpPr>
          <p:cNvPr id="7" name="Rechte verbindingslijn 6"/>
          <p:cNvCxnSpPr>
            <a:stCxn id="6" idx="1"/>
            <a:endCxn id="6" idx="3"/>
          </p:cNvCxnSpPr>
          <p:nvPr/>
        </p:nvCxnSpPr>
        <p:spPr>
          <a:xfrm>
            <a:off x="1627632" y="4601355"/>
            <a:ext cx="9875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7"/>
          <p:cNvSpPr txBox="1"/>
          <p:nvPr/>
        </p:nvSpPr>
        <p:spPr>
          <a:xfrm rot="16200000">
            <a:off x="888438" y="1975502"/>
            <a:ext cx="9915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CORE</a:t>
            </a:r>
            <a:endParaRPr lang="nl-BE" sz="2800" b="1" dirty="0"/>
          </a:p>
        </p:txBody>
      </p:sp>
      <p:sp>
        <p:nvSpPr>
          <p:cNvPr id="9" name="Tekstvak 8"/>
          <p:cNvSpPr txBox="1"/>
          <p:nvPr/>
        </p:nvSpPr>
        <p:spPr>
          <a:xfrm rot="16200000">
            <a:off x="-74549" y="6577197"/>
            <a:ext cx="29175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b="1" dirty="0" smtClean="0"/>
              <a:t>SUPERNUMERARY</a:t>
            </a:r>
            <a:endParaRPr lang="nl-BE" sz="2800" b="1" dirty="0"/>
          </a:p>
        </p:txBody>
      </p:sp>
      <p:pic>
        <p:nvPicPr>
          <p:cNvPr id="2" name="Afbeelding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3487" y="364575"/>
            <a:ext cx="9523809" cy="4161905"/>
          </a:xfrm>
          <a:prstGeom prst="rect">
            <a:avLst/>
          </a:prstGeom>
        </p:spPr>
      </p:pic>
      <p:pic>
        <p:nvPicPr>
          <p:cNvPr id="3" name="Afbeelding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03486" y="4693064"/>
            <a:ext cx="9523809" cy="41619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86983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Kantoorthema">
  <a:themeElements>
    <a:clrScheme name="Kantoorth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the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32</TotalTime>
  <Words>313</Words>
  <Application>Microsoft Office PowerPoint</Application>
  <PresentationFormat>Custom</PresentationFormat>
  <Paragraphs>112</Paragraphs>
  <Slides>3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4</vt:i4>
      </vt:variant>
    </vt:vector>
  </HeadingPairs>
  <TitlesOfParts>
    <vt:vector size="35" baseType="lpstr">
      <vt:lpstr>Kantoorthem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Gen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Adriaan Vanheule</dc:creator>
  <cp:lastModifiedBy>Calumpang, Mario Jade</cp:lastModifiedBy>
  <cp:revision>74</cp:revision>
  <dcterms:created xsi:type="dcterms:W3CDTF">2015-04-14T07:31:02Z</dcterms:created>
  <dcterms:modified xsi:type="dcterms:W3CDTF">2016-08-15T07:41:49Z</dcterms:modified>
</cp:coreProperties>
</file>